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60" r:id="rId1"/>
  </p:sldMasterIdLst>
  <p:notesMasterIdLst>
    <p:notesMasterId r:id="rId3"/>
  </p:notesMasterIdLst>
  <p:sldIdLst>
    <p:sldId id="294" r:id="rId2"/>
  </p:sldIdLst>
  <p:sldSz cx="9144000" cy="6858000" type="screen4x3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Hiroyuki Sasai" initials="HS" lastIdx="7" clrIdx="0">
    <p:extLst>
      <p:ext uri="{19B8F6BF-5375-455C-9EA6-DF929625EA0E}">
        <p15:presenceInfo xmlns:p15="http://schemas.microsoft.com/office/powerpoint/2012/main" userId="Hiroyuki Sasai" providerId="None"/>
      </p:ext>
    </p:extLst>
  </p:cmAuthor>
  <p:cmAuthor id="2" name="Nemoto Miyuki" initials="NM" lastIdx="13" clrIdx="1">
    <p:extLst>
      <p:ext uri="{19B8F6BF-5375-455C-9EA6-DF929625EA0E}">
        <p15:presenceInfo xmlns:p15="http://schemas.microsoft.com/office/powerpoint/2012/main" userId="457862ac872fa326" providerId="Windows Live"/>
      </p:ext>
    </p:extLst>
  </p:cmAuthor>
  <p:cmAuthor id="3" name="Hiroyuki Sasai" initials="HS [2]" lastIdx="6" clrIdx="2">
    <p:extLst>
      <p:ext uri="{19B8F6BF-5375-455C-9EA6-DF929625EA0E}">
        <p15:presenceInfo xmlns:p15="http://schemas.microsoft.com/office/powerpoint/2012/main" userId="2da4cb180539edf8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749452"/>
    <a:srgbClr val="BCB6BF"/>
    <a:srgbClr val="949B88"/>
    <a:srgbClr val="856F5C"/>
    <a:srgbClr val="FEF2E8"/>
    <a:srgbClr val="38D2F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75DCB02-9BB8-47FD-8907-85C794F793BA}" styleName="テーマ スタイル 1 - アクセント 4">
    <a:tblBg>
      <a:fillRef idx="2">
        <a:schemeClr val="accent4"/>
      </a:fillRef>
      <a:effectRef idx="1">
        <a:schemeClr val="accent4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Ref idx="1">
              <a:schemeClr val="accent4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  <a:fill>
          <a:solidFill>
            <a:schemeClr val="accent4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4"/>
            </a:lnRef>
          </a:left>
          <a:right>
            <a:lnRef idx="2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2">
              <a:schemeClr val="accent4"/>
            </a:lnRef>
          </a:top>
          <a:bottom>
            <a:lnRef idx="2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4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08FB837D-C827-4EFA-A057-4D05807E0F7C}" styleName="テーマ スタイル 1 - アクセント 6">
    <a:tblBg>
      <a:fillRef idx="2">
        <a:schemeClr val="accent6"/>
      </a:fillRef>
      <a:effectRef idx="1">
        <a:schemeClr val="accent6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Ref idx="1">
              <a:schemeClr val="accent6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  <a:fill>
          <a:solidFill>
            <a:schemeClr val="accent6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6"/>
            </a:lnRef>
          </a:left>
          <a:right>
            <a:lnRef idx="2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2">
              <a:schemeClr val="accent6"/>
            </a:lnRef>
          </a:top>
          <a:bottom>
            <a:lnRef idx="2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345" autoAdjust="0"/>
    <p:restoredTop sz="93343" autoAdjust="0"/>
  </p:normalViewPr>
  <p:slideViewPr>
    <p:cSldViewPr snapToGrid="0" showGuides="1">
      <p:cViewPr varScale="1">
        <p:scale>
          <a:sx n="96" d="100"/>
          <a:sy n="96" d="100"/>
        </p:scale>
        <p:origin x="980" y="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5838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12C61E9-A6EC-4EC5-B121-5B0598B7AF46}" type="datetimeFigureOut">
              <a:rPr kumimoji="1" lang="ja-JP" altLang="en-US" smtClean="0"/>
              <a:t>2020/4/1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68400" y="1243013"/>
            <a:ext cx="4470400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720" y="4783307"/>
            <a:ext cx="5445760" cy="3913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5838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A35B339-8AC6-4E96-BDBB-771F82D23A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95871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2B5DD-70FD-4C09-88A5-9F8AC1E50316}" type="datetimeFigureOut">
              <a:rPr kumimoji="1" lang="ja-JP" altLang="en-US" smtClean="0"/>
              <a:t>2020/4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1A31B-D4B4-4407-8D11-18397316A0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20572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2B5DD-70FD-4C09-88A5-9F8AC1E50316}" type="datetimeFigureOut">
              <a:rPr kumimoji="1" lang="ja-JP" altLang="en-US" smtClean="0"/>
              <a:t>2020/4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1A31B-D4B4-4407-8D11-18397316A0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83235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2B5DD-70FD-4C09-88A5-9F8AC1E50316}" type="datetimeFigureOut">
              <a:rPr kumimoji="1" lang="ja-JP" altLang="en-US" smtClean="0"/>
              <a:t>2020/4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1A31B-D4B4-4407-8D11-18397316A0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24983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2B5DD-70FD-4C09-88A5-9F8AC1E50316}" type="datetimeFigureOut">
              <a:rPr kumimoji="1" lang="ja-JP" altLang="en-US" smtClean="0"/>
              <a:t>2020/4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1A31B-D4B4-4407-8D11-18397316A0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50638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2B5DD-70FD-4C09-88A5-9F8AC1E50316}" type="datetimeFigureOut">
              <a:rPr kumimoji="1" lang="ja-JP" altLang="en-US" smtClean="0"/>
              <a:t>2020/4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1A31B-D4B4-4407-8D11-18397316A0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86260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2B5DD-70FD-4C09-88A5-9F8AC1E50316}" type="datetimeFigureOut">
              <a:rPr kumimoji="1" lang="ja-JP" altLang="en-US" smtClean="0"/>
              <a:t>2020/4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1A31B-D4B4-4407-8D11-18397316A0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65259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2B5DD-70FD-4C09-88A5-9F8AC1E50316}" type="datetimeFigureOut">
              <a:rPr kumimoji="1" lang="ja-JP" altLang="en-US" smtClean="0"/>
              <a:t>2020/4/1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1A31B-D4B4-4407-8D11-18397316A0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73490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2B5DD-70FD-4C09-88A5-9F8AC1E50316}" type="datetimeFigureOut">
              <a:rPr kumimoji="1" lang="ja-JP" altLang="en-US" smtClean="0"/>
              <a:t>2020/4/1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1A31B-D4B4-4407-8D11-18397316A0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47132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2B5DD-70FD-4C09-88A5-9F8AC1E50316}" type="datetimeFigureOut">
              <a:rPr kumimoji="1" lang="ja-JP" altLang="en-US" smtClean="0"/>
              <a:t>2020/4/1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1A31B-D4B4-4407-8D11-18397316A0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4270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2B5DD-70FD-4C09-88A5-9F8AC1E50316}" type="datetimeFigureOut">
              <a:rPr kumimoji="1" lang="ja-JP" altLang="en-US" smtClean="0"/>
              <a:t>2020/4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1A31B-D4B4-4407-8D11-18397316A0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70330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2B5DD-70FD-4C09-88A5-9F8AC1E50316}" type="datetimeFigureOut">
              <a:rPr kumimoji="1" lang="ja-JP" altLang="en-US" smtClean="0"/>
              <a:t>2020/4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1A31B-D4B4-4407-8D11-18397316A0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59787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12B5DD-70FD-4C09-88A5-9F8AC1E50316}" type="datetimeFigureOut">
              <a:rPr kumimoji="1" lang="ja-JP" altLang="en-US" smtClean="0"/>
              <a:t>2020/4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61A31B-D4B4-4407-8D11-18397316A0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22737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087" name="表 2086">
            <a:extLst>
              <a:ext uri="{FF2B5EF4-FFF2-40B4-BE49-F238E27FC236}">
                <a16:creationId xmlns:a16="http://schemas.microsoft.com/office/drawing/2014/main" id="{19758FD6-42A7-4CC1-AA5B-F2D7481A1B7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63459372"/>
              </p:ext>
            </p:extLst>
          </p:nvPr>
        </p:nvGraphicFramePr>
        <p:xfrm>
          <a:off x="2150164" y="695739"/>
          <a:ext cx="5251175" cy="5106053"/>
        </p:xfrm>
        <a:graphic>
          <a:graphicData uri="http://schemas.openxmlformats.org/drawingml/2006/table">
            <a:tbl>
              <a:tblPr/>
              <a:tblGrid>
                <a:gridCol w="5251175">
                  <a:extLst>
                    <a:ext uri="{9D8B030D-6E8A-4147-A177-3AD203B41FA5}">
                      <a16:colId xmlns:a16="http://schemas.microsoft.com/office/drawing/2014/main" val="1024529365"/>
                    </a:ext>
                  </a:extLst>
                </a:gridCol>
              </a:tblGrid>
              <a:tr h="4567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upplement 1. Evaluation criteria for the Clock Drawing Test </a:t>
                      </a:r>
                      <a:r>
                        <a:rPr lang="en-US" sz="14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[22]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756" marR="5756" marT="575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89323728"/>
                  </a:ext>
                </a:extLst>
              </a:tr>
              <a:tr h="231429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Overall</a:t>
                      </a:r>
                    </a:p>
                  </a:txBody>
                  <a:tcPr marL="5756" marR="5756" marT="575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43096051"/>
                  </a:ext>
                </a:extLst>
              </a:tr>
              <a:tr h="231429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1.   Be regular in figure</a:t>
                      </a:r>
                    </a:p>
                  </a:txBody>
                  <a:tcPr marL="5756" marR="5756" marT="575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27004700"/>
                  </a:ext>
                </a:extLst>
              </a:tr>
              <a:tr h="231429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    2.   Circle is proper size</a:t>
                      </a:r>
                    </a:p>
                  </a:txBody>
                  <a:tcPr marL="5756" marR="5756" marT="575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70399216"/>
                  </a:ext>
                </a:extLst>
              </a:tr>
              <a:tr h="231429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Numbers</a:t>
                      </a:r>
                    </a:p>
                  </a:txBody>
                  <a:tcPr marL="5756" marR="5756" marT="575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804070"/>
                  </a:ext>
                </a:extLst>
              </a:tr>
              <a:tr h="231429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3.   Only numbers 1–12 are present  </a:t>
                      </a:r>
                    </a:p>
                  </a:txBody>
                  <a:tcPr marL="5756" marR="5756" marT="575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67765713"/>
                  </a:ext>
                </a:extLst>
              </a:tr>
              <a:tr h="231429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4.   Only Arabic numbers are used </a:t>
                      </a:r>
                    </a:p>
                  </a:txBody>
                  <a:tcPr marL="5756" marR="5756" marT="575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06197032"/>
                  </a:ext>
                </a:extLst>
              </a:tr>
              <a:tr h="231429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5.   Numbers are in the correct order  </a:t>
                      </a:r>
                    </a:p>
                  </a:txBody>
                  <a:tcPr marL="5756" marR="5756" marT="575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37415819"/>
                  </a:ext>
                </a:extLst>
              </a:tr>
              <a:tr h="231429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6.   Numbers are drawn without rotating the paper </a:t>
                      </a:r>
                    </a:p>
                  </a:txBody>
                  <a:tcPr marL="5756" marR="5756" marT="575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98509808"/>
                  </a:ext>
                </a:extLst>
              </a:tr>
              <a:tr h="231429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7.   Numbers are in the correct position </a:t>
                      </a:r>
                    </a:p>
                  </a:txBody>
                  <a:tcPr marL="5756" marR="5756" marT="575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3995779"/>
                  </a:ext>
                </a:extLst>
              </a:tr>
              <a:tr h="231429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8.   Numbers are all inside the circle </a:t>
                      </a:r>
                    </a:p>
                  </a:txBody>
                  <a:tcPr marL="5756" marR="5756" marT="575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39532407"/>
                  </a:ext>
                </a:extLst>
              </a:tr>
              <a:tr h="231429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epiction of time (hands) </a:t>
                      </a:r>
                    </a:p>
                  </a:txBody>
                  <a:tcPr marL="5756" marR="5756" marT="575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99939906"/>
                  </a:ext>
                </a:extLst>
              </a:tr>
              <a:tr h="231429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9.   Two hands are present </a:t>
                      </a:r>
                    </a:p>
                  </a:txBody>
                  <a:tcPr marL="5756" marR="5756" marT="575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97824899"/>
                  </a:ext>
                </a:extLst>
              </a:tr>
              <a:tr h="231429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10. The hour target number is indicated </a:t>
                      </a:r>
                    </a:p>
                  </a:txBody>
                  <a:tcPr marL="5756" marR="5756" marT="575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44533414"/>
                  </a:ext>
                </a:extLst>
              </a:tr>
              <a:tr h="231429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11. The minute target number is indicated  </a:t>
                      </a:r>
                    </a:p>
                  </a:txBody>
                  <a:tcPr marL="5756" marR="5756" marT="575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82195437"/>
                  </a:ext>
                </a:extLst>
              </a:tr>
              <a:tr h="231429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12. The hands are in correct proportion </a:t>
                      </a:r>
                    </a:p>
                  </a:txBody>
                  <a:tcPr marL="5756" marR="5756" marT="575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63134384"/>
                  </a:ext>
                </a:extLst>
              </a:tr>
              <a:tr h="231429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13. There are no superfluous markings </a:t>
                      </a:r>
                    </a:p>
                  </a:txBody>
                  <a:tcPr marL="5756" marR="5756" marT="575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34283797"/>
                  </a:ext>
                </a:extLst>
              </a:tr>
              <a:tr h="231429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14. The hands are relatively joined </a:t>
                      </a:r>
                    </a:p>
                  </a:txBody>
                  <a:tcPr marL="5756" marR="5756" marT="575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94744660"/>
                  </a:ext>
                </a:extLst>
              </a:tr>
              <a:tr h="231429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enter </a:t>
                      </a:r>
                    </a:p>
                  </a:txBody>
                  <a:tcPr marL="5756" marR="5756" marT="575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02617856"/>
                  </a:ext>
                </a:extLst>
              </a:tr>
              <a:tr h="231429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15. A center is present at the joining of the hand</a:t>
                      </a:r>
                    </a:p>
                  </a:txBody>
                  <a:tcPr marL="5756" marR="5756" marT="575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66533449"/>
                  </a:ext>
                </a:extLst>
              </a:tr>
              <a:tr h="252123"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00"/>
                        </a:highlight>
                        <a:latin typeface="Palatino Linotype" panose="0204050205050503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756" marR="5756" marT="575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6600734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6239623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2007-2010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783</TotalTime>
  <Words>152</Words>
  <Application>Microsoft Office PowerPoint</Application>
  <PresentationFormat>画面に合わせる (4:3)</PresentationFormat>
  <Paragraphs>2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EMOTO Miyuki</dc:creator>
  <cp:lastModifiedBy>Nemoto Miyuki</cp:lastModifiedBy>
  <cp:revision>330</cp:revision>
  <cp:lastPrinted>2018-03-06T23:09:17Z</cp:lastPrinted>
  <dcterms:created xsi:type="dcterms:W3CDTF">2016-06-20T02:37:35Z</dcterms:created>
  <dcterms:modified xsi:type="dcterms:W3CDTF">2020-04-10T12:05:53Z</dcterms:modified>
</cp:coreProperties>
</file>